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EBF5E-7295-4089-9A15-C7745AEDC8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F2B7B-D418-4815-99A7-B6E936078E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BEDDE-911F-43DB-8745-01F80EC96E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BD0F3-0302-43A1-B02F-182CC8EBCC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FDAE2-5FB9-404D-B760-36F7FC4873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3E3F5-7331-41FE-B922-529B59F648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46CA4-DCBE-415F-8892-9E6FBA0F6B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A2310-E326-4A0D-A860-7B26D6B0F9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E3C45-7C05-4CDE-A286-DAD87B31BE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B1A3D-07C1-42ED-909C-DB5E6F1771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3BFD0-3BC1-4329-AB9D-C4F188C6DD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F8913-ECB4-4456-976F-86BBBF9C1B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505663-2508-431F-AE0D-3682B158AF9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31440" y="316080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age 3" descr="CS network.png"/>
          <p:cNvPicPr/>
          <p:nvPr/>
        </p:nvPicPr>
        <p:blipFill>
          <a:blip r:embed="rId1"/>
          <a:stretch/>
        </p:blipFill>
        <p:spPr>
          <a:xfrm>
            <a:off x="838080" y="598320"/>
            <a:ext cx="6782040" cy="6259680"/>
          </a:xfrm>
          <a:prstGeom prst="rect">
            <a:avLst/>
          </a:prstGeom>
          <a:ln w="0">
            <a:noFill/>
          </a:ln>
        </p:spPr>
      </p:pic>
      <p:sp>
        <p:nvSpPr>
          <p:cNvPr id="43" name="ZoneTexte 4"/>
          <p:cNvSpPr/>
          <p:nvPr/>
        </p:nvSpPr>
        <p:spPr>
          <a:xfrm>
            <a:off x="1229760" y="87480"/>
            <a:ext cx="6744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etwork of genes regulated upon cold shock stres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rcRect l="55700" t="62607" r="33971" b="27943"/>
          <a:stretch/>
        </p:blipFill>
        <p:spPr>
          <a:xfrm>
            <a:off x="7885080" y="836640"/>
            <a:ext cx="1008000" cy="115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age 3" descr="HS network.png"/>
          <p:cNvPicPr/>
          <p:nvPr/>
        </p:nvPicPr>
        <p:blipFill>
          <a:blip r:embed="rId1"/>
          <a:stretch/>
        </p:blipFill>
        <p:spPr>
          <a:xfrm>
            <a:off x="324000" y="536400"/>
            <a:ext cx="7086600" cy="6321600"/>
          </a:xfrm>
          <a:prstGeom prst="rect">
            <a:avLst/>
          </a:prstGeom>
          <a:ln w="0">
            <a:noFill/>
          </a:ln>
        </p:spPr>
      </p:pic>
      <p:sp>
        <p:nvSpPr>
          <p:cNvPr id="46" name="ZoneTexte 4"/>
          <p:cNvSpPr/>
          <p:nvPr/>
        </p:nvSpPr>
        <p:spPr>
          <a:xfrm>
            <a:off x="1185480" y="87480"/>
            <a:ext cx="678564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etwork of genes regulated upon heat shock stres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2"/>
          <a:srcRect l="55700" t="62607" r="33971" b="27943"/>
          <a:stretch/>
        </p:blipFill>
        <p:spPr>
          <a:xfrm>
            <a:off x="7885080" y="1125360"/>
            <a:ext cx="1008000" cy="115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2:37:34Z</dcterms:created>
  <dc:creator>quentin</dc:creator>
  <dc:description/>
  <dc:language>en-US</dc:language>
  <cp:lastModifiedBy>quentin</cp:lastModifiedBy>
  <dcterms:modified xsi:type="dcterms:W3CDTF">2010-09-30T12:37:42Z</dcterms:modified>
  <cp:revision>1</cp:revision>
  <dc:subject/>
  <dc:title>Diapositive 1</dc:title>
</cp:coreProperties>
</file>